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-117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128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878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802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138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57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171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776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01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800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390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691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CF8B7-312D-4F8D-B19C-4BD5B90FB5A9}" type="datetimeFigureOut">
              <a:rPr lang="en-US" smtClean="0"/>
              <a:t>8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396CB-711D-4941-B327-DCE5F2BDDB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293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406388"/>
            <a:ext cx="4791075" cy="3437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04800" y="6324600"/>
            <a:ext cx="3302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rr et al. Supplementary Figure 1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019801" y="1600200"/>
            <a:ext cx="28194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1.</a:t>
            </a:r>
          </a:p>
          <a:p>
            <a:r>
              <a:rPr lang="en-US" dirty="0" smtClean="0"/>
              <a:t>Gene expression of CCR7, CCL19, and CCL21 in adipose tissue of LFD vs HFD fed mice.</a:t>
            </a:r>
          </a:p>
        </p:txBody>
      </p:sp>
    </p:spTree>
    <p:extLst>
      <p:ext uri="{BB962C8B-B14F-4D97-AF65-F5344CB8AC3E}">
        <p14:creationId xmlns:p14="http://schemas.microsoft.com/office/powerpoint/2010/main" val="2701772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791200" y="1524000"/>
            <a:ext cx="32004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2.</a:t>
            </a:r>
          </a:p>
          <a:p>
            <a:r>
              <a:rPr lang="en-US" dirty="0" smtClean="0"/>
              <a:t>Gene expression of Abca1 and Plin2 in adipose tissue of LFD vs HFD fed WT and CCR7-/- mice.</a:t>
            </a:r>
          </a:p>
          <a:p>
            <a:endParaRPr lang="en-US" dirty="0"/>
          </a:p>
          <a:p>
            <a:r>
              <a:rPr lang="en-US" dirty="0" smtClean="0"/>
              <a:t>**** P&lt;0.001 for diet effect</a:t>
            </a: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52600"/>
            <a:ext cx="4924425" cy="3114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54817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59</Words>
  <Application>Microsoft Office PowerPoint</Application>
  <PresentationFormat>On-screen Show (4:3)</PresentationFormat>
  <Paragraphs>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3</cp:revision>
  <dcterms:created xsi:type="dcterms:W3CDTF">2016-08-12T14:59:26Z</dcterms:created>
  <dcterms:modified xsi:type="dcterms:W3CDTF">2016-08-12T20:50:54Z</dcterms:modified>
</cp:coreProperties>
</file>